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2" autoAdjust="0"/>
    <p:restoredTop sz="96374" autoAdjust="0"/>
  </p:normalViewPr>
  <p:slideViewPr>
    <p:cSldViewPr snapToGrid="0">
      <p:cViewPr varScale="1">
        <p:scale>
          <a:sx n="110" d="100"/>
          <a:sy n="110" d="100"/>
        </p:scale>
        <p:origin x="600" y="10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3B3306-33BD-43D9-B67C-4E9ADC6E4232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C8E7A7-2553-484F-A02E-25F9DEEE53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677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C8E7A7-2553-484F-A02E-25F9DEEE537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88432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3739A-48B0-4B1A-A01E-FFE7F4199B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3D1C56-CDD1-44E6-B03E-37E73F6EDF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6CA038-28B2-4B44-9213-F2A81A865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7E6AFF-B87D-45F4-AF10-AFD75FFBD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FBF691-BF37-4C42-8F36-19BC55A91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8279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DE6AB-A26C-4FE4-88B6-035303A784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A753B2-DD70-4F21-A19F-CFB0B18AC1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3BD9C6-F6C9-4EDE-B716-5A1384121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2EB0E1-B559-4D41-8B5F-3104655EB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0221DA-DFF6-468D-BF16-1DF91FD70A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7841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C6BF9E-483F-48FB-B881-845197A0B1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4E59EE-83DC-437C-91A2-DFCA38AB50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32C77A-7DFB-473F-828E-D4C350D6F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1FAEC-3FD4-4239-A30E-58EF3B3CC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AB4E84-EDE5-45EF-8786-D80743188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9163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2AE58-9FC5-4409-A598-B441326767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FAF478-3BDF-416E-96AC-E8313E178C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16B63-9837-4B18-B780-68E0B04E8A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2A6C85-653C-4705-B581-4866691AA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813E57-9D57-4BDE-A2B6-0FF5BE106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793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2192D-C3E6-4FE3-8636-8C48C29BDD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CF5480-14DD-4CB7-A257-81C60EC45A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BE766D-CA7F-4176-8C34-6E133AED5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C5F3C6-E34E-4AC6-9637-3263C65EC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A075AB-A457-4434-99E8-C61501243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3806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FE8F2B-87A2-4412-AB8D-17BE0CB0EF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C641EE-BFC2-422A-9C89-BBE40504DC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D1C2AC-155B-4AEC-B067-817F2174AC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ED82D3-5D0C-439B-A9A5-A29774DB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55C802-AF83-4AFE-9ACE-865D3E255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AC95FE-D23B-4FB0-AA7A-695703AAD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2811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22C0F2-62B2-47C5-95A3-759EDAAFB8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C87BA0-A734-4D57-AA2C-31EBE2E234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B32058-F4E1-432D-B802-69B5027211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CACCED-601A-45D7-9474-89AD9D8588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AE9DB5-374D-4A34-A2C3-737739077D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C05048-3111-4DFE-BAD4-6C5AEF9CA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85D874-CD64-480F-A613-C82EA6803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B953D8-AAEB-4B50-B25A-E4802E620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28977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3A160D-7D14-40BF-B656-A79D65FEFB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2B8A62-5F9E-4B9F-87B8-D195EC78D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07FA5B-B4AA-4E61-B2BD-FD0C95550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BAD505-77F5-44E9-B575-AC2D44395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373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12797A-5A89-4276-8537-2D6265606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040C9D-3EB4-411B-A072-B0BF0DDAE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E0C438-66BD-441E-84ED-49AC20C40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4107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CA918-E3B9-4FDB-B232-9529547484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81F7A5-636A-4CC3-8571-353BF7B796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8C56C5-C13C-4042-ABDE-B538A718D4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8B933B-3BC4-4934-85C6-B009DE7D9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7341E6-7BD2-403C-97E2-714307D15F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FA5B6B-5FC4-42DD-B39A-84C655484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021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C1B52-DB43-4413-9B4C-0421038F5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081DAE-B0AC-445A-94E5-3EA025BE41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FBD3CD-7283-4621-BA43-C4BF994436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3C6FF2-037D-4EF3-B509-7C828ACE05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FAC827-DA1B-4E65-A50A-3B53831DC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47F920-6E91-403B-A14B-1A3EEE9C1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0838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A9171C-F944-468A-8F67-17AB212915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29D1D1-940E-4EBF-9DDC-3754CA190C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1DA3E0-B350-47BA-8C8F-9A83FE87EE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672FA6-71F5-46B4-98FB-C4D286BE94BF}" type="datetimeFigureOut">
              <a:rPr lang="en-GB" smtClean="0"/>
              <a:t>16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C797E1-54FB-4BE7-9BC2-2EEBF9001E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93916B-4998-4B30-B0B4-BDF5358616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557B2-E38F-46EA-8A36-787E272D3C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747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69B1CF2B-0242-49B2-A633-BAC894AB09A3}"/>
              </a:ext>
            </a:extLst>
          </p:cNvPr>
          <p:cNvSpPr txBox="1"/>
          <p:nvPr/>
        </p:nvSpPr>
        <p:spPr>
          <a:xfrm>
            <a:off x="95808" y="5875139"/>
            <a:ext cx="11939438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l"/>
            <a:r>
              <a:rPr lang="en-GB" sz="1200" b="1" dirty="0"/>
              <a:t>Additional File 10a:</a:t>
            </a:r>
            <a:r>
              <a:rPr lang="en-GB" sz="1200" dirty="0"/>
              <a:t> Heat maps displaying p-value and log</a:t>
            </a:r>
            <a:r>
              <a:rPr lang="en-GB" sz="1200" baseline="-25000" dirty="0"/>
              <a:t>2</a:t>
            </a:r>
            <a:r>
              <a:rPr lang="en-GB" sz="1200" dirty="0"/>
              <a:t> fold-change of the top 5 genes per radiation dose, direction of log</a:t>
            </a:r>
            <a:r>
              <a:rPr lang="en-GB" sz="1200" baseline="-25000" dirty="0"/>
              <a:t>2</a:t>
            </a:r>
            <a:r>
              <a:rPr lang="en-GB" sz="1200" dirty="0"/>
              <a:t> fold-change per group-wise comparison for expression models including group-dose interaction (with regard to p-value). Log</a:t>
            </a:r>
            <a:r>
              <a:rPr lang="en-GB" sz="1200" baseline="-25000" dirty="0"/>
              <a:t>2</a:t>
            </a:r>
            <a:r>
              <a:rPr lang="en-GB" sz="1200" dirty="0"/>
              <a:t> fold-change values can be found inside the tiles. Only the results for model 1 (considering age at sampling and sex) are displayed. </a:t>
            </a:r>
            <a:r>
              <a:rPr lang="en-GB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 N0 = fibroblasts of cancer-free </a:t>
            </a:r>
            <a:r>
              <a:rPr lang="en-GB" sz="1200" dirty="0">
                <a:solidFill>
                  <a:srgbClr val="000000"/>
                </a:solidFill>
                <a:latin typeface="Calibri" panose="020F0502020204030204" pitchFamily="34" charset="0"/>
              </a:rPr>
              <a:t>controls</a:t>
            </a:r>
            <a:r>
              <a:rPr lang="en-GB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, N1 = fibroblasts of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donors with a first primary neoplasm</a:t>
            </a:r>
            <a:r>
              <a:rPr lang="en-GB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, N2+ = fibroblasts of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donors with </a:t>
            </a:r>
            <a:r>
              <a:rPr lang="en-GB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at least one second primary neoplasm. 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* </a:t>
            </a:r>
            <a:r>
              <a:rPr lang="en-US" sz="1200" b="0" i="1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p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-value &lt; 0.05, ** </a:t>
            </a:r>
            <a:r>
              <a:rPr lang="en-US" sz="1200" b="0" i="1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p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-value &lt; 0.01, *** </a:t>
            </a:r>
            <a:r>
              <a:rPr lang="en-US" sz="1200" b="0" i="1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p</a:t>
            </a:r>
            <a:r>
              <a:rPr lang="en-US" sz="12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-value &lt; 0.001 (adjusted for false discovery rate). </a:t>
            </a:r>
          </a:p>
          <a:p>
            <a:pPr algn="l"/>
            <a:endParaRPr lang="en-GB" sz="12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3FE96E8-A9DD-4702-B2FF-F6C6F00492B3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804" y="54813"/>
            <a:ext cx="5760000" cy="57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6C2367C-0C2C-49AA-9F30-4C3266F7C689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1598" y="54813"/>
            <a:ext cx="5760000" cy="57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1A3F2AE-5AA5-4625-B11C-5B33FF1C0A07}"/>
              </a:ext>
            </a:extLst>
          </p:cNvPr>
          <p:cNvSpPr txBox="1"/>
          <p:nvPr/>
        </p:nvSpPr>
        <p:spPr>
          <a:xfrm>
            <a:off x="10922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1/N2+ vs N0</a:t>
            </a:r>
            <a:endParaRPr lang="de-DE" sz="7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14900A-72B4-4D2D-9EE1-B3443C9BD91F}"/>
              </a:ext>
            </a:extLst>
          </p:cNvPr>
          <p:cNvSpPr txBox="1"/>
          <p:nvPr/>
        </p:nvSpPr>
        <p:spPr>
          <a:xfrm>
            <a:off x="20066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1 vs N0</a:t>
            </a:r>
            <a:endParaRPr lang="de-DE" sz="7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D37C97-AEC6-430C-BC91-7F67C20049B5}"/>
              </a:ext>
            </a:extLst>
          </p:cNvPr>
          <p:cNvSpPr txBox="1"/>
          <p:nvPr/>
        </p:nvSpPr>
        <p:spPr>
          <a:xfrm>
            <a:off x="29210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2+ vs N0</a:t>
            </a:r>
            <a:endParaRPr lang="de-DE" sz="7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76A7488-64DE-4A8B-85DE-288B6EFDD4EE}"/>
              </a:ext>
            </a:extLst>
          </p:cNvPr>
          <p:cNvSpPr txBox="1"/>
          <p:nvPr/>
        </p:nvSpPr>
        <p:spPr>
          <a:xfrm>
            <a:off x="38354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2+ vs N1</a:t>
            </a:r>
            <a:endParaRPr lang="de-DE" sz="7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4A599A-9BC3-41FE-847E-C84A3F082B02}"/>
              </a:ext>
            </a:extLst>
          </p:cNvPr>
          <p:cNvSpPr txBox="1"/>
          <p:nvPr/>
        </p:nvSpPr>
        <p:spPr>
          <a:xfrm>
            <a:off x="69850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1/N2+ vs N0</a:t>
            </a:r>
            <a:endParaRPr lang="de-DE" sz="7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0D079DD-0089-423E-AE4B-64BDA79400FE}"/>
              </a:ext>
            </a:extLst>
          </p:cNvPr>
          <p:cNvSpPr txBox="1"/>
          <p:nvPr/>
        </p:nvSpPr>
        <p:spPr>
          <a:xfrm>
            <a:off x="78994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1 vs N0</a:t>
            </a:r>
            <a:endParaRPr lang="de-DE" sz="7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EAFD65B-FBCF-47BE-BF01-CC0F6674B634}"/>
              </a:ext>
            </a:extLst>
          </p:cNvPr>
          <p:cNvSpPr txBox="1"/>
          <p:nvPr/>
        </p:nvSpPr>
        <p:spPr>
          <a:xfrm>
            <a:off x="88138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2+ vs N0</a:t>
            </a:r>
            <a:endParaRPr lang="de-DE" sz="7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6BC45B9-9A89-4FA3-8CB5-F79EC1A156AE}"/>
              </a:ext>
            </a:extLst>
          </p:cNvPr>
          <p:cNvSpPr txBox="1"/>
          <p:nvPr/>
        </p:nvSpPr>
        <p:spPr>
          <a:xfrm>
            <a:off x="9728200" y="5394326"/>
            <a:ext cx="914400" cy="20637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700" b="1" dirty="0"/>
              <a:t>N2+ vs N1</a:t>
            </a:r>
            <a:endParaRPr lang="de-DE" sz="700" b="1" dirty="0"/>
          </a:p>
        </p:txBody>
      </p:sp>
    </p:spTree>
    <p:extLst>
      <p:ext uri="{BB962C8B-B14F-4D97-AF65-F5344CB8AC3E}">
        <p14:creationId xmlns:p14="http://schemas.microsoft.com/office/powerpoint/2010/main" val="2395913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>
            <a:extLst>
              <a:ext uri="{FF2B5EF4-FFF2-40B4-BE49-F238E27FC236}">
                <a16:creationId xmlns:a16="http://schemas.microsoft.com/office/drawing/2014/main" id="{BD0991BB-BA30-44CF-ADFA-8AEE814C6EFB}"/>
              </a:ext>
            </a:extLst>
          </p:cNvPr>
          <p:cNvSpPr txBox="1"/>
          <p:nvPr/>
        </p:nvSpPr>
        <p:spPr>
          <a:xfrm rot="5400000">
            <a:off x="10076865" y="3762746"/>
            <a:ext cx="25272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2 Gray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9850996-8ACD-4493-97BE-F6A62A83BAC1}"/>
              </a:ext>
            </a:extLst>
          </p:cNvPr>
          <p:cNvSpPr txBox="1"/>
          <p:nvPr/>
        </p:nvSpPr>
        <p:spPr>
          <a:xfrm rot="5400000">
            <a:off x="10075993" y="1185635"/>
            <a:ext cx="2527200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0.05 Gra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AB7BB7-39C0-484D-B508-BC3D6A520D0F}"/>
              </a:ext>
            </a:extLst>
          </p:cNvPr>
          <p:cNvSpPr txBox="1"/>
          <p:nvPr/>
        </p:nvSpPr>
        <p:spPr>
          <a:xfrm>
            <a:off x="906320" y="5257836"/>
            <a:ext cx="2532327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N1/N2+ compared to N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02A26D-A829-40E9-90A1-261DE738475F}"/>
              </a:ext>
            </a:extLst>
          </p:cNvPr>
          <p:cNvSpPr txBox="1"/>
          <p:nvPr/>
        </p:nvSpPr>
        <p:spPr>
          <a:xfrm>
            <a:off x="3464444" y="5257836"/>
            <a:ext cx="2533122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N1 compared to N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FB1B201-B0EB-4B11-B99A-3667D188AB0E}"/>
              </a:ext>
            </a:extLst>
          </p:cNvPr>
          <p:cNvSpPr txBox="1"/>
          <p:nvPr/>
        </p:nvSpPr>
        <p:spPr>
          <a:xfrm>
            <a:off x="6035192" y="5257836"/>
            <a:ext cx="2529734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N2+ compared to N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7D519A-86CD-42C8-90ED-F5AEDB185E6C}"/>
              </a:ext>
            </a:extLst>
          </p:cNvPr>
          <p:cNvSpPr txBox="1"/>
          <p:nvPr/>
        </p:nvSpPr>
        <p:spPr>
          <a:xfrm>
            <a:off x="8598773" y="5257836"/>
            <a:ext cx="2538768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N2+ compared to N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17A099-7E58-458E-AF8F-5A17AF7D1155}"/>
              </a:ext>
            </a:extLst>
          </p:cNvPr>
          <p:cNvSpPr txBox="1"/>
          <p:nvPr/>
        </p:nvSpPr>
        <p:spPr>
          <a:xfrm>
            <a:off x="95808" y="5736598"/>
            <a:ext cx="11969192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400" b="1"/>
              <a:t>Additional </a:t>
            </a:r>
            <a:r>
              <a:rPr lang="en-GB" sz="1400" b="1" dirty="0"/>
              <a:t>File 10b:</a:t>
            </a:r>
            <a:r>
              <a:rPr lang="en-GB" sz="1400" dirty="0"/>
              <a:t> Tree maps displaying clustered top gene ontology terms for the top 50 genes (with regard to p-value) </a:t>
            </a:r>
          </a:p>
          <a:p>
            <a:pPr algn="l"/>
            <a:r>
              <a:rPr lang="en-GB" sz="1400" dirty="0"/>
              <a:t>for expression models including group-dose interaction (with regard to p-value) for each group-wise comparison. Only the results for model 1 (considering age and sex) are displayed.  </a:t>
            </a:r>
            <a:r>
              <a:rPr lang="en-GB" sz="14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N0 = fibroblasts of cancer-free </a:t>
            </a:r>
            <a:r>
              <a:rPr lang="en-GB" sz="1400" dirty="0">
                <a:solidFill>
                  <a:srgbClr val="000000"/>
                </a:solidFill>
                <a:latin typeface="Calibri" panose="020F0502020204030204" pitchFamily="34" charset="0"/>
              </a:rPr>
              <a:t>controls</a:t>
            </a:r>
            <a:r>
              <a:rPr lang="en-GB" sz="14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, N1 = fibroblasts of </a:t>
            </a:r>
            <a:r>
              <a:rPr lang="en-US" sz="14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donors with a first primary neoplasm</a:t>
            </a:r>
            <a:r>
              <a:rPr lang="en-GB" sz="14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, N2+ = fibroblasts of </a:t>
            </a:r>
            <a:r>
              <a:rPr lang="en-US" sz="14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donors with </a:t>
            </a:r>
            <a:r>
              <a:rPr lang="en-GB" sz="14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at least one second primary neoplasm.</a:t>
            </a:r>
            <a:endParaRPr lang="en-GB" sz="14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6A22D20-9EFA-4DDA-A019-95974CB36171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1813" y="2691656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AAD108F-1F08-42B3-A184-BA289ACAD6FE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0285" y="114548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A3F376F-B687-48AE-9F92-03C8969CE574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269" y="2686192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51537EE-B285-470B-A7C0-4F6DB423F867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269" y="109784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21A2613-43A2-4B6F-832A-021D806AF337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9565" y="2685381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3AD76AF-B9D6-4FE6-AC67-3216C7BC4E89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9295" y="115249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D497A74-9E1D-4567-9427-6772114BBF9A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5758" y="2685381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7E9802AF-0B00-4044-9626-F4D2EC6C0A48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3480" y="102987"/>
            <a:ext cx="2520000" cy="25200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949360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6</Words>
  <Application>Microsoft Office PowerPoint</Application>
  <PresentationFormat>Widescreen</PresentationFormat>
  <Paragraphs>1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ine Grandt</dc:creator>
  <cp:lastModifiedBy>Caine Grandt</cp:lastModifiedBy>
  <cp:revision>127</cp:revision>
  <dcterms:created xsi:type="dcterms:W3CDTF">2020-09-14T11:46:10Z</dcterms:created>
  <dcterms:modified xsi:type="dcterms:W3CDTF">2022-07-16T17:01:30Z</dcterms:modified>
</cp:coreProperties>
</file>